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8639175" cy="10691813"/>
  <p:notesSz cx="6858000" cy="9144000"/>
  <p:defaultTextStyle>
    <a:defPPr>
      <a:defRPr lang="ja-JP"/>
    </a:defPPr>
    <a:lvl1pPr marL="0" algn="l" defTabSz="1077986" rtl="0" eaLnBrk="1" latinLnBrk="0" hangingPunct="1">
      <a:defRPr kumimoji="1" sz="2122" kern="1200">
        <a:solidFill>
          <a:schemeClr val="tx1"/>
        </a:solidFill>
        <a:latin typeface="+mn-lt"/>
        <a:ea typeface="+mn-ea"/>
        <a:cs typeface="+mn-cs"/>
      </a:defRPr>
    </a:lvl1pPr>
    <a:lvl2pPr marL="538993" algn="l" defTabSz="1077986" rtl="0" eaLnBrk="1" latinLnBrk="0" hangingPunct="1">
      <a:defRPr kumimoji="1" sz="2122" kern="1200">
        <a:solidFill>
          <a:schemeClr val="tx1"/>
        </a:solidFill>
        <a:latin typeface="+mn-lt"/>
        <a:ea typeface="+mn-ea"/>
        <a:cs typeface="+mn-cs"/>
      </a:defRPr>
    </a:lvl2pPr>
    <a:lvl3pPr marL="1077986" algn="l" defTabSz="1077986" rtl="0" eaLnBrk="1" latinLnBrk="0" hangingPunct="1">
      <a:defRPr kumimoji="1" sz="2122" kern="1200">
        <a:solidFill>
          <a:schemeClr val="tx1"/>
        </a:solidFill>
        <a:latin typeface="+mn-lt"/>
        <a:ea typeface="+mn-ea"/>
        <a:cs typeface="+mn-cs"/>
      </a:defRPr>
    </a:lvl3pPr>
    <a:lvl4pPr marL="1616979" algn="l" defTabSz="1077986" rtl="0" eaLnBrk="1" latinLnBrk="0" hangingPunct="1">
      <a:defRPr kumimoji="1" sz="2122" kern="1200">
        <a:solidFill>
          <a:schemeClr val="tx1"/>
        </a:solidFill>
        <a:latin typeface="+mn-lt"/>
        <a:ea typeface="+mn-ea"/>
        <a:cs typeface="+mn-cs"/>
      </a:defRPr>
    </a:lvl4pPr>
    <a:lvl5pPr marL="2155972" algn="l" defTabSz="1077986" rtl="0" eaLnBrk="1" latinLnBrk="0" hangingPunct="1">
      <a:defRPr kumimoji="1" sz="2122" kern="1200">
        <a:solidFill>
          <a:schemeClr val="tx1"/>
        </a:solidFill>
        <a:latin typeface="+mn-lt"/>
        <a:ea typeface="+mn-ea"/>
        <a:cs typeface="+mn-cs"/>
      </a:defRPr>
    </a:lvl5pPr>
    <a:lvl6pPr marL="2694965" algn="l" defTabSz="1077986" rtl="0" eaLnBrk="1" latinLnBrk="0" hangingPunct="1">
      <a:defRPr kumimoji="1" sz="2122" kern="1200">
        <a:solidFill>
          <a:schemeClr val="tx1"/>
        </a:solidFill>
        <a:latin typeface="+mn-lt"/>
        <a:ea typeface="+mn-ea"/>
        <a:cs typeface="+mn-cs"/>
      </a:defRPr>
    </a:lvl6pPr>
    <a:lvl7pPr marL="3233958" algn="l" defTabSz="1077986" rtl="0" eaLnBrk="1" latinLnBrk="0" hangingPunct="1">
      <a:defRPr kumimoji="1" sz="2122" kern="1200">
        <a:solidFill>
          <a:schemeClr val="tx1"/>
        </a:solidFill>
        <a:latin typeface="+mn-lt"/>
        <a:ea typeface="+mn-ea"/>
        <a:cs typeface="+mn-cs"/>
      </a:defRPr>
    </a:lvl7pPr>
    <a:lvl8pPr marL="3772952" algn="l" defTabSz="1077986" rtl="0" eaLnBrk="1" latinLnBrk="0" hangingPunct="1">
      <a:defRPr kumimoji="1" sz="2122" kern="1200">
        <a:solidFill>
          <a:schemeClr val="tx1"/>
        </a:solidFill>
        <a:latin typeface="+mn-lt"/>
        <a:ea typeface="+mn-ea"/>
        <a:cs typeface="+mn-cs"/>
      </a:defRPr>
    </a:lvl8pPr>
    <a:lvl9pPr marL="4311945" algn="l" defTabSz="1077986" rtl="0" eaLnBrk="1" latinLnBrk="0" hangingPunct="1">
      <a:defRPr kumimoji="1" sz="2122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3" d="100"/>
          <a:sy n="43" d="100"/>
        </p:scale>
        <p:origin x="215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47938" y="1749795"/>
            <a:ext cx="7343299" cy="3722335"/>
          </a:xfrm>
        </p:spPr>
        <p:txBody>
          <a:bodyPr anchor="b"/>
          <a:lstStyle>
            <a:lvl1pPr algn="ctr">
              <a:defRPr sz="566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79897" y="5615678"/>
            <a:ext cx="6479381" cy="2581379"/>
          </a:xfrm>
        </p:spPr>
        <p:txBody>
          <a:bodyPr/>
          <a:lstStyle>
            <a:lvl1pPr marL="0" indent="0" algn="ctr">
              <a:buNone/>
              <a:defRPr sz="2268"/>
            </a:lvl1pPr>
            <a:lvl2pPr marL="431963" indent="0" algn="ctr">
              <a:buNone/>
              <a:defRPr sz="1890"/>
            </a:lvl2pPr>
            <a:lvl3pPr marL="863925" indent="0" algn="ctr">
              <a:buNone/>
              <a:defRPr sz="1701"/>
            </a:lvl3pPr>
            <a:lvl4pPr marL="1295888" indent="0" algn="ctr">
              <a:buNone/>
              <a:defRPr sz="1512"/>
            </a:lvl4pPr>
            <a:lvl5pPr marL="1727850" indent="0" algn="ctr">
              <a:buNone/>
              <a:defRPr sz="1512"/>
            </a:lvl5pPr>
            <a:lvl6pPr marL="2159813" indent="0" algn="ctr">
              <a:buNone/>
              <a:defRPr sz="1512"/>
            </a:lvl6pPr>
            <a:lvl7pPr marL="2591775" indent="0" algn="ctr">
              <a:buNone/>
              <a:defRPr sz="1512"/>
            </a:lvl7pPr>
            <a:lvl8pPr marL="3023738" indent="0" algn="ctr">
              <a:buNone/>
              <a:defRPr sz="1512"/>
            </a:lvl8pPr>
            <a:lvl9pPr marL="3455700" indent="0" algn="ctr">
              <a:buNone/>
              <a:defRPr sz="1512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E9965-1E66-43A4-A11C-501089128829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729CA-6DED-4D01-BC89-D2BF699717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8337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E9965-1E66-43A4-A11C-501089128829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729CA-6DED-4D01-BC89-D2BF699717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54906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82410" y="569240"/>
            <a:ext cx="1862822" cy="90608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3944" y="569240"/>
            <a:ext cx="5480477" cy="90608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E9965-1E66-43A4-A11C-501089128829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729CA-6DED-4D01-BC89-D2BF699717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12871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E9965-1E66-43A4-A11C-501089128829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729CA-6DED-4D01-BC89-D2BF699717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7879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9444" y="2665532"/>
            <a:ext cx="7451288" cy="4447496"/>
          </a:xfrm>
        </p:spPr>
        <p:txBody>
          <a:bodyPr anchor="b"/>
          <a:lstStyle>
            <a:lvl1pPr>
              <a:defRPr sz="5669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9444" y="7155103"/>
            <a:ext cx="7451288" cy="2338833"/>
          </a:xfrm>
        </p:spPr>
        <p:txBody>
          <a:bodyPr/>
          <a:lstStyle>
            <a:lvl1pPr marL="0" indent="0">
              <a:buNone/>
              <a:defRPr sz="2268">
                <a:solidFill>
                  <a:schemeClr val="tx1"/>
                </a:solidFill>
              </a:defRPr>
            </a:lvl1pPr>
            <a:lvl2pPr marL="431963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2pPr>
            <a:lvl3pPr marL="863925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3pPr>
            <a:lvl4pPr marL="1295888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4pPr>
            <a:lvl5pPr marL="1727850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5pPr>
            <a:lvl6pPr marL="2159813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6pPr>
            <a:lvl7pPr marL="2591775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7pPr>
            <a:lvl8pPr marL="3023738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8pPr>
            <a:lvl9pPr marL="3455700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E9965-1E66-43A4-A11C-501089128829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729CA-6DED-4D01-BC89-D2BF699717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92597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3943" y="2846200"/>
            <a:ext cx="3671649" cy="6783857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73583" y="2846200"/>
            <a:ext cx="3671649" cy="6783857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E9965-1E66-43A4-A11C-501089128829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729CA-6DED-4D01-BC89-D2BF699717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4066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069" y="569242"/>
            <a:ext cx="7451288" cy="2066590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5070" y="2620980"/>
            <a:ext cx="3654775" cy="1284502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1963" indent="0">
              <a:buNone/>
              <a:defRPr sz="1890" b="1"/>
            </a:lvl2pPr>
            <a:lvl3pPr marL="863925" indent="0">
              <a:buNone/>
              <a:defRPr sz="1701" b="1"/>
            </a:lvl3pPr>
            <a:lvl4pPr marL="1295888" indent="0">
              <a:buNone/>
              <a:defRPr sz="1512" b="1"/>
            </a:lvl4pPr>
            <a:lvl5pPr marL="1727850" indent="0">
              <a:buNone/>
              <a:defRPr sz="1512" b="1"/>
            </a:lvl5pPr>
            <a:lvl6pPr marL="2159813" indent="0">
              <a:buNone/>
              <a:defRPr sz="1512" b="1"/>
            </a:lvl6pPr>
            <a:lvl7pPr marL="2591775" indent="0">
              <a:buNone/>
              <a:defRPr sz="1512" b="1"/>
            </a:lvl7pPr>
            <a:lvl8pPr marL="3023738" indent="0">
              <a:buNone/>
              <a:defRPr sz="1512" b="1"/>
            </a:lvl8pPr>
            <a:lvl9pPr marL="3455700" indent="0">
              <a:buNone/>
              <a:defRPr sz="1512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5070" y="3905482"/>
            <a:ext cx="3654775" cy="5744375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73583" y="2620980"/>
            <a:ext cx="3672775" cy="1284502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1963" indent="0">
              <a:buNone/>
              <a:defRPr sz="1890" b="1"/>
            </a:lvl2pPr>
            <a:lvl3pPr marL="863925" indent="0">
              <a:buNone/>
              <a:defRPr sz="1701" b="1"/>
            </a:lvl3pPr>
            <a:lvl4pPr marL="1295888" indent="0">
              <a:buNone/>
              <a:defRPr sz="1512" b="1"/>
            </a:lvl4pPr>
            <a:lvl5pPr marL="1727850" indent="0">
              <a:buNone/>
              <a:defRPr sz="1512" b="1"/>
            </a:lvl5pPr>
            <a:lvl6pPr marL="2159813" indent="0">
              <a:buNone/>
              <a:defRPr sz="1512" b="1"/>
            </a:lvl6pPr>
            <a:lvl7pPr marL="2591775" indent="0">
              <a:buNone/>
              <a:defRPr sz="1512" b="1"/>
            </a:lvl7pPr>
            <a:lvl8pPr marL="3023738" indent="0">
              <a:buNone/>
              <a:defRPr sz="1512" b="1"/>
            </a:lvl8pPr>
            <a:lvl9pPr marL="3455700" indent="0">
              <a:buNone/>
              <a:defRPr sz="1512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73583" y="3905482"/>
            <a:ext cx="3672775" cy="5744375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E9965-1E66-43A4-A11C-501089128829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729CA-6DED-4D01-BC89-D2BF699717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93501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E9965-1E66-43A4-A11C-501089128829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729CA-6DED-4D01-BC89-D2BF699717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8898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E9965-1E66-43A4-A11C-501089128829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729CA-6DED-4D01-BC89-D2BF699717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4149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068" y="712788"/>
            <a:ext cx="2786359" cy="2494756"/>
          </a:xfrm>
        </p:spPr>
        <p:txBody>
          <a:bodyPr anchor="b"/>
          <a:lstStyle>
            <a:lvl1pPr>
              <a:defRPr sz="3023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72775" y="1539425"/>
            <a:ext cx="4373582" cy="7598117"/>
          </a:xfrm>
        </p:spPr>
        <p:txBody>
          <a:bodyPr/>
          <a:lstStyle>
            <a:lvl1pPr>
              <a:defRPr sz="3023"/>
            </a:lvl1pPr>
            <a:lvl2pPr>
              <a:defRPr sz="2645"/>
            </a:lvl2pPr>
            <a:lvl3pPr>
              <a:defRPr sz="2268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068" y="3207544"/>
            <a:ext cx="2786359" cy="5942372"/>
          </a:xfrm>
        </p:spPr>
        <p:txBody>
          <a:bodyPr/>
          <a:lstStyle>
            <a:lvl1pPr marL="0" indent="0">
              <a:buNone/>
              <a:defRPr sz="1512"/>
            </a:lvl1pPr>
            <a:lvl2pPr marL="431963" indent="0">
              <a:buNone/>
              <a:defRPr sz="1323"/>
            </a:lvl2pPr>
            <a:lvl3pPr marL="863925" indent="0">
              <a:buNone/>
              <a:defRPr sz="1134"/>
            </a:lvl3pPr>
            <a:lvl4pPr marL="1295888" indent="0">
              <a:buNone/>
              <a:defRPr sz="945"/>
            </a:lvl4pPr>
            <a:lvl5pPr marL="1727850" indent="0">
              <a:buNone/>
              <a:defRPr sz="945"/>
            </a:lvl5pPr>
            <a:lvl6pPr marL="2159813" indent="0">
              <a:buNone/>
              <a:defRPr sz="945"/>
            </a:lvl6pPr>
            <a:lvl7pPr marL="2591775" indent="0">
              <a:buNone/>
              <a:defRPr sz="945"/>
            </a:lvl7pPr>
            <a:lvl8pPr marL="3023738" indent="0">
              <a:buNone/>
              <a:defRPr sz="945"/>
            </a:lvl8pPr>
            <a:lvl9pPr marL="3455700" indent="0">
              <a:buNone/>
              <a:defRPr sz="94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E9965-1E66-43A4-A11C-501089128829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729CA-6DED-4D01-BC89-D2BF699717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5418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5068" y="712788"/>
            <a:ext cx="2786359" cy="2494756"/>
          </a:xfrm>
        </p:spPr>
        <p:txBody>
          <a:bodyPr anchor="b"/>
          <a:lstStyle>
            <a:lvl1pPr>
              <a:defRPr sz="3023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672775" y="1539425"/>
            <a:ext cx="4373582" cy="7598117"/>
          </a:xfrm>
        </p:spPr>
        <p:txBody>
          <a:bodyPr anchor="t"/>
          <a:lstStyle>
            <a:lvl1pPr marL="0" indent="0">
              <a:buNone/>
              <a:defRPr sz="3023"/>
            </a:lvl1pPr>
            <a:lvl2pPr marL="431963" indent="0">
              <a:buNone/>
              <a:defRPr sz="2645"/>
            </a:lvl2pPr>
            <a:lvl3pPr marL="863925" indent="0">
              <a:buNone/>
              <a:defRPr sz="2268"/>
            </a:lvl3pPr>
            <a:lvl4pPr marL="1295888" indent="0">
              <a:buNone/>
              <a:defRPr sz="1890"/>
            </a:lvl4pPr>
            <a:lvl5pPr marL="1727850" indent="0">
              <a:buNone/>
              <a:defRPr sz="1890"/>
            </a:lvl5pPr>
            <a:lvl6pPr marL="2159813" indent="0">
              <a:buNone/>
              <a:defRPr sz="1890"/>
            </a:lvl6pPr>
            <a:lvl7pPr marL="2591775" indent="0">
              <a:buNone/>
              <a:defRPr sz="1890"/>
            </a:lvl7pPr>
            <a:lvl8pPr marL="3023738" indent="0">
              <a:buNone/>
              <a:defRPr sz="1890"/>
            </a:lvl8pPr>
            <a:lvl9pPr marL="3455700" indent="0">
              <a:buNone/>
              <a:defRPr sz="189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5068" y="3207544"/>
            <a:ext cx="2786359" cy="5942372"/>
          </a:xfrm>
        </p:spPr>
        <p:txBody>
          <a:bodyPr/>
          <a:lstStyle>
            <a:lvl1pPr marL="0" indent="0">
              <a:buNone/>
              <a:defRPr sz="1512"/>
            </a:lvl1pPr>
            <a:lvl2pPr marL="431963" indent="0">
              <a:buNone/>
              <a:defRPr sz="1323"/>
            </a:lvl2pPr>
            <a:lvl3pPr marL="863925" indent="0">
              <a:buNone/>
              <a:defRPr sz="1134"/>
            </a:lvl3pPr>
            <a:lvl4pPr marL="1295888" indent="0">
              <a:buNone/>
              <a:defRPr sz="945"/>
            </a:lvl4pPr>
            <a:lvl5pPr marL="1727850" indent="0">
              <a:buNone/>
              <a:defRPr sz="945"/>
            </a:lvl5pPr>
            <a:lvl6pPr marL="2159813" indent="0">
              <a:buNone/>
              <a:defRPr sz="945"/>
            </a:lvl6pPr>
            <a:lvl7pPr marL="2591775" indent="0">
              <a:buNone/>
              <a:defRPr sz="945"/>
            </a:lvl7pPr>
            <a:lvl8pPr marL="3023738" indent="0">
              <a:buNone/>
              <a:defRPr sz="945"/>
            </a:lvl8pPr>
            <a:lvl9pPr marL="3455700" indent="0">
              <a:buNone/>
              <a:defRPr sz="94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FBE9965-1E66-43A4-A11C-501089128829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F729CA-6DED-4D01-BC89-D2BF699717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97219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93944" y="569242"/>
            <a:ext cx="7451288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3944" y="2846200"/>
            <a:ext cx="7451288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3943" y="9909729"/>
            <a:ext cx="194381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BE9965-1E66-43A4-A11C-501089128829}" type="datetimeFigureOut">
              <a:rPr kumimoji="1" lang="ja-JP" altLang="en-US" smtClean="0"/>
              <a:t>2016/3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61727" y="9909729"/>
            <a:ext cx="2915722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101418" y="9909729"/>
            <a:ext cx="1943814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F729CA-6DED-4D01-BC89-D2BF699717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3037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863925" rtl="0" eaLnBrk="1" latinLnBrk="0" hangingPunct="1">
        <a:lnSpc>
          <a:spcPct val="90000"/>
        </a:lnSpc>
        <a:spcBef>
          <a:spcPct val="0"/>
        </a:spcBef>
        <a:buNone/>
        <a:defRPr kumimoji="1" sz="415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5981" indent="-215981" algn="l" defTabSz="863925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kumimoji="1" sz="2645" kern="1200">
          <a:solidFill>
            <a:schemeClr val="tx1"/>
          </a:solidFill>
          <a:latin typeface="+mn-lt"/>
          <a:ea typeface="+mn-ea"/>
          <a:cs typeface="+mn-cs"/>
        </a:defRPr>
      </a:lvl1pPr>
      <a:lvl2pPr marL="647944" indent="-215981" algn="l" defTabSz="863925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kumimoji="1" sz="2268" kern="1200">
          <a:solidFill>
            <a:schemeClr val="tx1"/>
          </a:solidFill>
          <a:latin typeface="+mn-lt"/>
          <a:ea typeface="+mn-ea"/>
          <a:cs typeface="+mn-cs"/>
        </a:defRPr>
      </a:lvl2pPr>
      <a:lvl3pPr marL="1079906" indent="-215981" algn="l" defTabSz="863925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511869" indent="-215981" algn="l" defTabSz="863925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943832" indent="-215981" algn="l" defTabSz="863925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375794" indent="-215981" algn="l" defTabSz="863925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807757" indent="-215981" algn="l" defTabSz="863925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239719" indent="-215981" algn="l" defTabSz="863925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671682" indent="-215981" algn="l" defTabSz="863925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63925" rtl="0" eaLnBrk="1" latinLnBrk="0" hangingPunct="1"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1pPr>
      <a:lvl2pPr marL="431963" algn="l" defTabSz="863925" rtl="0" eaLnBrk="1" latinLnBrk="0" hangingPunct="1"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63925" algn="l" defTabSz="863925" rtl="0" eaLnBrk="1" latinLnBrk="0" hangingPunct="1"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3pPr>
      <a:lvl4pPr marL="1295888" algn="l" defTabSz="863925" rtl="0" eaLnBrk="1" latinLnBrk="0" hangingPunct="1"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727850" algn="l" defTabSz="863925" rtl="0" eaLnBrk="1" latinLnBrk="0" hangingPunct="1"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159813" algn="l" defTabSz="863925" rtl="0" eaLnBrk="1" latinLnBrk="0" hangingPunct="1"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591775" algn="l" defTabSz="863925" rtl="0" eaLnBrk="1" latinLnBrk="0" hangingPunct="1"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023738" algn="l" defTabSz="863925" rtl="0" eaLnBrk="1" latinLnBrk="0" hangingPunct="1"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455700" algn="l" defTabSz="863925" rtl="0" eaLnBrk="1" latinLnBrk="0" hangingPunct="1">
        <a:defRPr kumimoji="1" sz="17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/>
          <p:cNvGrpSpPr/>
          <p:nvPr/>
        </p:nvGrpSpPr>
        <p:grpSpPr>
          <a:xfrm>
            <a:off x="156117" y="227444"/>
            <a:ext cx="8307840" cy="7595173"/>
            <a:chOff x="0" y="0"/>
            <a:chExt cx="10829925" cy="9986962"/>
          </a:xfrm>
        </p:grpSpPr>
        <p:pic>
          <p:nvPicPr>
            <p:cNvPr id="5" name="図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71183" y="5329237"/>
              <a:ext cx="3952875" cy="4657725"/>
            </a:xfrm>
            <a:prstGeom prst="rect">
              <a:avLst/>
            </a:prstGeom>
          </p:spPr>
        </p:pic>
        <p:pic>
          <p:nvPicPr>
            <p:cNvPr id="6" name="図 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92886" y="5329237"/>
              <a:ext cx="3962400" cy="4629150"/>
            </a:xfrm>
            <a:prstGeom prst="rect">
              <a:avLst/>
            </a:prstGeom>
          </p:spPr>
        </p:pic>
        <p:grpSp>
          <p:nvGrpSpPr>
            <p:cNvPr id="7" name="グループ化 6"/>
            <p:cNvGrpSpPr/>
            <p:nvPr/>
          </p:nvGrpSpPr>
          <p:grpSpPr>
            <a:xfrm>
              <a:off x="0" y="0"/>
              <a:ext cx="10829925" cy="4429125"/>
              <a:chOff x="0" y="0"/>
              <a:chExt cx="10829925" cy="4429125"/>
            </a:xfrm>
          </p:grpSpPr>
          <p:grpSp>
            <p:nvGrpSpPr>
              <p:cNvPr id="10" name="グループ化 9"/>
              <p:cNvGrpSpPr/>
              <p:nvPr/>
            </p:nvGrpSpPr>
            <p:grpSpPr>
              <a:xfrm>
                <a:off x="0" y="0"/>
                <a:ext cx="10829925" cy="4429125"/>
                <a:chOff x="0" y="0"/>
                <a:chExt cx="10829925" cy="4429125"/>
              </a:xfrm>
            </p:grpSpPr>
            <p:pic>
              <p:nvPicPr>
                <p:cNvPr id="12" name="図 11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0" y="0"/>
                  <a:ext cx="10829925" cy="4429125"/>
                </a:xfrm>
                <a:prstGeom prst="rect">
                  <a:avLst/>
                </a:prstGeom>
              </p:spPr>
            </p:pic>
            <p:sp>
              <p:nvSpPr>
                <p:cNvPr id="13" name="正方形/長方形 12"/>
                <p:cNvSpPr/>
                <p:nvPr/>
              </p:nvSpPr>
              <p:spPr>
                <a:xfrm>
                  <a:off x="2873587" y="2197261"/>
                  <a:ext cx="45718" cy="2220038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ja-JP" altLang="en-US" sz="2425"/>
                </a:p>
              </p:txBody>
            </p:sp>
          </p:grpSp>
          <p:sp>
            <p:nvSpPr>
              <p:cNvPr id="11" name="正方形/長方形 10"/>
              <p:cNvSpPr/>
              <p:nvPr/>
            </p:nvSpPr>
            <p:spPr>
              <a:xfrm>
                <a:off x="8491969" y="2188190"/>
                <a:ext cx="45718" cy="2220038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endParaRPr lang="ja-JP" altLang="en-US" sz="2425"/>
              </a:p>
            </p:txBody>
          </p:sp>
        </p:grpSp>
        <p:cxnSp>
          <p:nvCxnSpPr>
            <p:cNvPr id="8" name="直線矢印コネクタ 7"/>
            <p:cNvCxnSpPr/>
            <p:nvPr/>
          </p:nvCxnSpPr>
          <p:spPr>
            <a:xfrm flipH="1">
              <a:off x="2885554" y="4408228"/>
              <a:ext cx="13249" cy="897197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線矢印コネクタ 8"/>
            <p:cNvCxnSpPr>
              <a:stCxn id="11" idx="2"/>
            </p:cNvCxnSpPr>
            <p:nvPr/>
          </p:nvCxnSpPr>
          <p:spPr>
            <a:xfrm flipH="1">
              <a:off x="8514828" y="4408229"/>
              <a:ext cx="2" cy="92101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" name="正方形/長方形 13"/>
          <p:cNvSpPr/>
          <p:nvPr/>
        </p:nvSpPr>
        <p:spPr>
          <a:xfrm>
            <a:off x="123117" y="8213397"/>
            <a:ext cx="8516058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altLang="zh-CN" sz="1800" b="1" kern="100" smtClean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1 </a:t>
            </a:r>
            <a:r>
              <a:rPr lang="en-US" altLang="ja-JP" sz="1800" b="1" kern="100" smtClean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Figure</a:t>
            </a:r>
            <a:r>
              <a:rPr lang="en-US" altLang="ja-JP" sz="1800" b="1" kern="100" dirty="0" smtClean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  </a:t>
            </a:r>
            <a:r>
              <a:rPr lang="en-US" altLang="ja-JP" sz="1800" b="1" kern="100" dirty="0" smtClean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GV view of putative Em-TSP3 isoforms in pathogen_EMU_scaffold_007780 of </a:t>
            </a:r>
            <a:r>
              <a:rPr lang="en-US" altLang="ja-JP" sz="1800" b="1" i="1" kern="100" dirty="0" smtClean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. </a:t>
            </a:r>
            <a:r>
              <a:rPr lang="en-US" altLang="ja-JP" sz="1800" b="1" i="1" kern="100" dirty="0" err="1" smtClean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ultilocularis</a:t>
            </a:r>
            <a:r>
              <a:rPr lang="en-US" altLang="ja-JP" sz="1800" b="1" kern="100" dirty="0" smtClean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enome versions 3. </a:t>
            </a:r>
            <a:r>
              <a:rPr lang="en-US" altLang="ja-JP" sz="1800" kern="100" dirty="0" smtClean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five tracks show the mapped result of EmuJ_001077300 (gene start: 13002559, gene end:</a:t>
            </a:r>
            <a:r>
              <a:rPr lang="en-US" altLang="ja-JP" sz="1800" kern="100" dirty="0" smtClean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800" kern="100" dirty="0" smtClean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3003475) and EmuJ_001077400 (gene start: 13008382, gene end: 13009298) which all most reads can mapped to the two</a:t>
            </a:r>
            <a:r>
              <a:rPr lang="en-US" altLang="ja-JP" sz="1800" kern="100" dirty="0" smtClean="0">
                <a:effectLst/>
                <a:latin typeface="Century" panose="020406040505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800" kern="100" dirty="0" smtClean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utative Em-TSP3 isoforms. At the locus of 13002639 and 13008462, there was two common single-nucleotide polymorphisms (SNPs) but the ratio of the two SNPs were obviously different among the samples.</a:t>
            </a:r>
            <a:endParaRPr lang="ja-JP" altLang="ja-JP" sz="18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077362" y="6040631"/>
            <a:ext cx="371192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986793" y="6029089"/>
            <a:ext cx="651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c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063781" y="6374520"/>
            <a:ext cx="271604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986793" y="6386521"/>
            <a:ext cx="651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c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063782" y="6707011"/>
            <a:ext cx="212758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986793" y="6713632"/>
            <a:ext cx="651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063781" y="7059063"/>
            <a:ext cx="271604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977740" y="7076031"/>
            <a:ext cx="6609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met</a:t>
            </a:r>
            <a:endParaRPr kumimoji="1"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068307" y="7412980"/>
            <a:ext cx="199178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977740" y="7401438"/>
            <a:ext cx="715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met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063781" y="7736722"/>
            <a:ext cx="561281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977740" y="7631018"/>
            <a:ext cx="905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5163897" y="6029089"/>
            <a:ext cx="244444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5163897" y="6352485"/>
            <a:ext cx="244444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5144685" y="6707011"/>
            <a:ext cx="244444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5159371" y="7040224"/>
            <a:ext cx="244444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5140825" y="7367402"/>
            <a:ext cx="244444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5140825" y="7690696"/>
            <a:ext cx="371192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5077890" y="6006006"/>
            <a:ext cx="651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c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5077890" y="6363438"/>
            <a:ext cx="651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c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5077890" y="6690549"/>
            <a:ext cx="6518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5068837" y="7052948"/>
            <a:ext cx="6609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met</a:t>
            </a:r>
            <a:endParaRPr kumimoji="1" lang="en-US" altLang="ja-JP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5060221" y="7379008"/>
            <a:ext cx="715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met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5068837" y="7607935"/>
            <a:ext cx="905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222191" y="1922803"/>
            <a:ext cx="333286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222191" y="2265074"/>
            <a:ext cx="333286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222191" y="2614791"/>
            <a:ext cx="333286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222191" y="2957062"/>
            <a:ext cx="333286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239283" y="3306779"/>
            <a:ext cx="333286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119244" y="1958932"/>
            <a:ext cx="965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c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119244" y="2256257"/>
            <a:ext cx="965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onc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119244" y="2595609"/>
            <a:ext cx="965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nc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135556" y="2929743"/>
            <a:ext cx="965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met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124815" y="3262788"/>
            <a:ext cx="9656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3346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113</Words>
  <Application>Microsoft Office PowerPoint</Application>
  <PresentationFormat>ユーザー設定</PresentationFormat>
  <Paragraphs>1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9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1" baseType="lpstr">
      <vt:lpstr>ＭＳ Ｐゴシック</vt:lpstr>
      <vt:lpstr>ＭＳ 明朝</vt:lpstr>
      <vt:lpstr>SimSun</vt:lpstr>
      <vt:lpstr>SimSun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黄福强</dc:creator>
  <cp:lastModifiedBy>黄福强</cp:lastModifiedBy>
  <cp:revision>8</cp:revision>
  <dcterms:created xsi:type="dcterms:W3CDTF">2016-01-22T10:27:06Z</dcterms:created>
  <dcterms:modified xsi:type="dcterms:W3CDTF">2016-03-24T06:53:50Z</dcterms:modified>
</cp:coreProperties>
</file>